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275" r:id="rId2"/>
    <p:sldId id="276" r:id="rId3"/>
    <p:sldId id="277" r:id="rId4"/>
    <p:sldId id="260" r:id="rId5"/>
  </p:sldIdLst>
  <p:sldSz cx="12192000" cy="6858000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640EF9B2-F158-558A-5617-4F3AC6173CFA}" name="Akiko Saito" initials="AS" userId="Akiko Saito" providerId="None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1"/>
    <p:restoredTop sz="96197"/>
  </p:normalViewPr>
  <p:slideViewPr>
    <p:cSldViewPr snapToGrid="0">
      <p:cViewPr varScale="1">
        <p:scale>
          <a:sx n="111" d="100"/>
          <a:sy n="111" d="100"/>
        </p:scale>
        <p:origin x="47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microsoft.com/office/2018/10/relationships/authors" Target="authors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8B77F42-18DE-574D-9E0C-9E56D0197A76}" type="datetimeFigureOut">
              <a:rPr kumimoji="1" lang="ja-JP" altLang="en-US" smtClean="0"/>
              <a:t>2023/2/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1425"/>
            <a:ext cx="595312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5436B85-7336-7D4A-A4AE-148A60E031F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657098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ja-JP" altLang="en-US"/>
              <a:t>今回の試験対象者。</a:t>
            </a:r>
            <a:endParaRPr kumimoji="1" lang="en-US" altLang="ja-JP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C208C22-AD42-4912-A18E-AF28CE53ADFB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664909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ja-JP" altLang="en-US"/>
              <a:t>こちらも</a:t>
            </a:r>
            <a:r>
              <a:rPr kumimoji="1" lang="en-US" altLang="ja-JP" dirty="0" err="1"/>
              <a:t>Kiguchi</a:t>
            </a:r>
            <a:r>
              <a:rPr kumimoji="1" lang="ja-JP" altLang="en-US"/>
              <a:t>論文で使用した図になりますが、</a:t>
            </a:r>
            <a:r>
              <a:rPr kumimoji="1" lang="en-US" altLang="ja-JP" dirty="0" err="1"/>
              <a:t>IFNg</a:t>
            </a:r>
            <a:r>
              <a:rPr kumimoji="1" lang="ja-JP" altLang="en-US"/>
              <a:t>については、</a:t>
            </a:r>
            <a:r>
              <a:rPr kumimoji="1" lang="en-US" altLang="ja-JP" dirty="0"/>
              <a:t>IgG</a:t>
            </a:r>
            <a:r>
              <a:rPr kumimoji="1" lang="ja-JP" altLang="en-US"/>
              <a:t>に比べ反応率が低く、ワクチン開始からの時間や値も不安定であった。</a:t>
            </a: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C208C22-AD42-4912-A18E-AF28CE53ADFB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391522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64D1F34-882B-DBA0-969D-001E394A978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6DF5A83C-71AA-1904-42F5-597BE1C71B6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811FFD5-15F9-C4A2-1451-0EA1C0690A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E5AED-0F18-174E-9E58-71D22665643A}" type="datetimeFigureOut">
              <a:rPr kumimoji="1" lang="ja-JP" altLang="en-US" smtClean="0"/>
              <a:t>2023/2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0F957E0-6DC5-5F9E-A3B6-353269C66E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6A7276C-CA1F-2A29-1134-9AAAE35A73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927A3-715B-1F44-96A6-1E9A6A2215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636819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2F77697-17E6-6CCE-A9FD-2EC36993C5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73536228-9E80-D153-1253-4B24B3B21C0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5C22D4E-C3FE-28A2-EC5A-2A7BF284DB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E5AED-0F18-174E-9E58-71D22665643A}" type="datetimeFigureOut">
              <a:rPr kumimoji="1" lang="ja-JP" altLang="en-US" smtClean="0"/>
              <a:t>2023/2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01C8350-B23D-3A62-64CE-3CDE340CB7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ADCC129-E0CB-72F8-818F-FCDACDB143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927A3-715B-1F44-96A6-1E9A6A2215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698017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A0850E80-7514-A4D5-3516-60659A922B6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B49865F-67EC-557F-B412-CA9E843A529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2853BDF-B6C2-4BB0-F74F-3B984CB07D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E5AED-0F18-174E-9E58-71D22665643A}" type="datetimeFigureOut">
              <a:rPr kumimoji="1" lang="ja-JP" altLang="en-US" smtClean="0"/>
              <a:t>2023/2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9B25FB3-CED7-31C4-9A52-7AA8ED06A3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2372D39-EA87-D55A-06DE-11339DF878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927A3-715B-1F44-96A6-1E9A6A2215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14648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E0BF93C-0A75-1A03-E69B-AD142CEB9A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A49E7E2-5A57-ABF9-8FEE-12FD68DF369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167B9A6-F720-EE1E-17D6-903E9F1897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E5AED-0F18-174E-9E58-71D22665643A}" type="datetimeFigureOut">
              <a:rPr kumimoji="1" lang="ja-JP" altLang="en-US" smtClean="0"/>
              <a:t>2023/2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CC77887-E48B-AA82-5F74-EFE6AA5AEA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7D55C67-B302-A90E-8A30-F8EA174238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927A3-715B-1F44-96A6-1E9A6A2215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094659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7573804-A4F2-235F-3001-54A5316EFD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8AFBE882-9BB2-F873-9B7B-A7976D6EA67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84A4863-1310-A370-7E96-51E706BEF4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E5AED-0F18-174E-9E58-71D22665643A}" type="datetimeFigureOut">
              <a:rPr kumimoji="1" lang="ja-JP" altLang="en-US" smtClean="0"/>
              <a:t>2023/2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4F3C540-0E4F-B456-3598-4ED932C5C8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B46BCE6-AE81-250B-09C5-E891C27653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927A3-715B-1F44-96A6-1E9A6A2215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61298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EA072A2-C06F-0111-014E-FC1DF137D7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9FCDE68-3F41-E613-4F3F-7C412AD523C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623C600-5D9B-0AA9-9DEB-055F621ECF3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23432D84-3F75-4DD1-5003-18E65865F6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E5AED-0F18-174E-9E58-71D22665643A}" type="datetimeFigureOut">
              <a:rPr kumimoji="1" lang="ja-JP" altLang="en-US" smtClean="0"/>
              <a:t>2023/2/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51BB5FF-04E6-5FA7-FB8E-83C55CBDEC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40CFB03-2883-EA23-E647-DF6764EEA2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927A3-715B-1F44-96A6-1E9A6A2215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82660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C19EA27-7801-4E8D-C6DF-8EECEFC90F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5D943BE8-8B04-5649-CF1B-8247FFB2C7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619B47B-E90B-473B-B337-909A446CA3F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9C878CA6-624C-D116-F0A8-18A1032F96A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3FD52B58-86B3-9922-4FDE-B91048BB0BC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D7366999-481A-F713-5B03-4E7F7C5C60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E5AED-0F18-174E-9E58-71D22665643A}" type="datetimeFigureOut">
              <a:rPr kumimoji="1" lang="ja-JP" altLang="en-US" smtClean="0"/>
              <a:t>2023/2/7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92CD93F6-C3C8-9F3A-539F-C79A1EF2EA8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F04103FE-B0D6-2EB1-4DC2-B380FFC1BD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927A3-715B-1F44-96A6-1E9A6A2215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74740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68E4B39-2B01-D5A5-8D2A-0B97D4699C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BBED51CB-3AB1-8B7E-FB76-B4A1B41692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E5AED-0F18-174E-9E58-71D22665643A}" type="datetimeFigureOut">
              <a:rPr kumimoji="1" lang="ja-JP" altLang="en-US" smtClean="0"/>
              <a:t>2023/2/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6A4AACE4-A8B5-1489-1FEC-3FF0E76B43B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B3454813-9F91-32E6-4827-4653041670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927A3-715B-1F44-96A6-1E9A6A2215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54475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375EB541-7554-6C96-9F79-07A7BBC906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E5AED-0F18-174E-9E58-71D22665643A}" type="datetimeFigureOut">
              <a:rPr kumimoji="1" lang="ja-JP" altLang="en-US" smtClean="0"/>
              <a:t>2023/2/7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5FC5BA4F-AA1E-A046-025B-6BAA754956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F2E3F7C0-72C0-E8EE-C055-385C18B257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927A3-715B-1F44-96A6-1E9A6A2215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14113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DBE76A9-9BB0-51B7-8B8D-2DF5398473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154F7ED7-C0BB-1B9E-C0DE-6BE8EF16B98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8166CAC-3E92-CC1B-A4E9-15283397462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741D7B1-D8C8-28FA-73CA-E9265AEA61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E5AED-0F18-174E-9E58-71D22665643A}" type="datetimeFigureOut">
              <a:rPr kumimoji="1" lang="ja-JP" altLang="en-US" smtClean="0"/>
              <a:t>2023/2/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51FCA295-B85E-558A-CA21-919CE4B00E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B5EE9CD-A38A-E681-3A78-E3E929B1AA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927A3-715B-1F44-96A6-1E9A6A2215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806723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2584C4E6-7020-0F5C-D982-F0E36C0DE1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08B011C5-872C-F7BC-95E7-7FB1E6BBD39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7306290-8570-5DD7-F587-256428468D5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7A071D7-01B2-428F-497F-7356C77933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EE5AED-0F18-174E-9E58-71D22665643A}" type="datetimeFigureOut">
              <a:rPr kumimoji="1" lang="ja-JP" altLang="en-US" smtClean="0"/>
              <a:t>2023/2/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B07B3AB6-83BE-E24B-8346-D72634840A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6C22D79D-2A02-8697-AD21-D71A05DCE5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D927A3-715B-1F44-96A6-1E9A6A2215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999859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A9871F5-1BD7-A7BB-69F6-178E77A709A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CE7D8FD-10C2-F1D0-B0FD-B183ABEB264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5213E16-81B7-013C-6459-BC17349C5BF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EE5AED-0F18-174E-9E58-71D22665643A}" type="datetimeFigureOut">
              <a:rPr kumimoji="1" lang="ja-JP" altLang="en-US" smtClean="0"/>
              <a:t>2023/2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C252F66-E1E8-4DCA-721C-A8859759083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627EB089-0E3D-BBF1-A49D-376357F69E5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D927A3-715B-1F44-96A6-1E9A6A22153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96643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DCA8BC6-28D1-FF3B-B6F4-826A06AEDE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05971" y="355497"/>
            <a:ext cx="10515600" cy="823595"/>
          </a:xfrm>
        </p:spPr>
        <p:txBody>
          <a:bodyPr>
            <a:normAutofit/>
          </a:bodyPr>
          <a:lstStyle/>
          <a:p>
            <a:r>
              <a:rPr kumimoji="1" lang="en-US" altLang="ja-JP" sz="2400" b="1" dirty="0"/>
              <a:t>[Suppl. Table 1</a:t>
            </a:r>
            <a:r>
              <a:rPr kumimoji="1" lang="en-US" altLang="ja-JP" sz="2400" dirty="0"/>
              <a:t>] Patients' characteristics</a:t>
            </a:r>
            <a:endParaRPr kumimoji="1" lang="ja-JP" altLang="en-US" sz="2400" dirty="0"/>
          </a:p>
        </p:txBody>
      </p:sp>
      <p:graphicFrame>
        <p:nvGraphicFramePr>
          <p:cNvPr id="4" name="表 3">
            <a:extLst>
              <a:ext uri="{FF2B5EF4-FFF2-40B4-BE49-F238E27FC236}">
                <a16:creationId xmlns:a16="http://schemas.microsoft.com/office/drawing/2014/main" id="{46993BD0-263F-E6C8-CCD5-000AC5014EF0}"/>
              </a:ext>
            </a:extLst>
          </p:cNvPr>
          <p:cNvGraphicFramePr>
            <a:graphicFrameLocks noGrp="1"/>
          </p:cNvGraphicFramePr>
          <p:nvPr/>
        </p:nvGraphicFramePr>
        <p:xfrm>
          <a:off x="386080" y="1267029"/>
          <a:ext cx="11419839" cy="5235474"/>
        </p:xfrm>
        <a:graphic>
          <a:graphicData uri="http://schemas.openxmlformats.org/drawingml/2006/table">
            <a:tbl>
              <a:tblPr/>
              <a:tblGrid>
                <a:gridCol w="591703">
                  <a:extLst>
                    <a:ext uri="{9D8B030D-6E8A-4147-A177-3AD203B41FA5}">
                      <a16:colId xmlns:a16="http://schemas.microsoft.com/office/drawing/2014/main" val="136924323"/>
                    </a:ext>
                  </a:extLst>
                </a:gridCol>
                <a:gridCol w="6390377">
                  <a:extLst>
                    <a:ext uri="{9D8B030D-6E8A-4147-A177-3AD203B41FA5}">
                      <a16:colId xmlns:a16="http://schemas.microsoft.com/office/drawing/2014/main" val="3179201749"/>
                    </a:ext>
                  </a:extLst>
                </a:gridCol>
                <a:gridCol w="1479253">
                  <a:extLst>
                    <a:ext uri="{9D8B030D-6E8A-4147-A177-3AD203B41FA5}">
                      <a16:colId xmlns:a16="http://schemas.microsoft.com/office/drawing/2014/main" val="383347420"/>
                    </a:ext>
                  </a:extLst>
                </a:gridCol>
                <a:gridCol w="1479253">
                  <a:extLst>
                    <a:ext uri="{9D8B030D-6E8A-4147-A177-3AD203B41FA5}">
                      <a16:colId xmlns:a16="http://schemas.microsoft.com/office/drawing/2014/main" val="2537534521"/>
                    </a:ext>
                  </a:extLst>
                </a:gridCol>
                <a:gridCol w="1479253">
                  <a:extLst>
                    <a:ext uri="{9D8B030D-6E8A-4147-A177-3AD203B41FA5}">
                      <a16:colId xmlns:a16="http://schemas.microsoft.com/office/drawing/2014/main" val="2022109367"/>
                    </a:ext>
                  </a:extLst>
                </a:gridCol>
              </a:tblGrid>
              <a:tr h="214946">
                <a:tc>
                  <a:txBody>
                    <a:bodyPr/>
                    <a:lstStyle/>
                    <a:p>
                      <a:pPr rtl="0" fontAlgn="b"/>
                      <a:endParaRPr lang="ja-JP" altLang="en-US" sz="1400">
                        <a:effectLst/>
                      </a:endParaRPr>
                    </a:p>
                  </a:txBody>
                  <a:tcPr marL="19660" marR="19660" marT="13106" marB="13106" anchor="b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b"/>
                      <a:endParaRPr lang="ja-JP" altLang="en-US" sz="1400">
                        <a:effectLst/>
                      </a:endParaRPr>
                    </a:p>
                  </a:txBody>
                  <a:tcPr marL="19660" marR="19660" marT="13106" marB="13106" anchor="b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1">
                          <a:effectLst/>
                        </a:rPr>
                        <a:t>OCV-501</a:t>
                      </a: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1">
                          <a:effectLst/>
                        </a:rPr>
                        <a:t>Placebo</a:t>
                      </a: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sz="1400" b="1">
                          <a:effectLst/>
                        </a:rPr>
                        <a:t>Total</a:t>
                      </a: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95504108"/>
                  </a:ext>
                </a:extLst>
              </a:tr>
              <a:tr h="141550">
                <a:tc gridSpan="2">
                  <a:txBody>
                    <a:bodyPr/>
                    <a:lstStyle/>
                    <a:p>
                      <a:pPr rtl="0" fontAlgn="b"/>
                      <a:r>
                        <a:rPr lang="en-US" sz="1400" b="1">
                          <a:effectLst/>
                        </a:rPr>
                        <a:t>Number of patients</a:t>
                      </a:r>
                    </a:p>
                  </a:txBody>
                  <a:tcPr marL="19660" marR="19660" marT="13106" marB="13106" anchor="b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>
                          <a:effectLst/>
                        </a:rPr>
                        <a:t>52</a:t>
                      </a: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>
                          <a:effectLst/>
                        </a:rPr>
                        <a:t>53</a:t>
                      </a: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>
                          <a:effectLst/>
                        </a:rPr>
                        <a:t>105</a:t>
                      </a: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27796961"/>
                  </a:ext>
                </a:extLst>
              </a:tr>
              <a:tr h="214946">
                <a:tc gridSpan="2">
                  <a:txBody>
                    <a:bodyPr/>
                    <a:lstStyle/>
                    <a:p>
                      <a:pPr rtl="0" fontAlgn="b"/>
                      <a:r>
                        <a:rPr lang="en-US" sz="1400" b="1">
                          <a:effectLst/>
                        </a:rPr>
                        <a:t>Age</a:t>
                      </a:r>
                    </a:p>
                  </a:txBody>
                  <a:tcPr marL="19660" marR="19660" marT="13106" marB="13106" anchor="b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0" fontAlgn="ctr"/>
                      <a:endParaRPr lang="ja-JP" altLang="en-US" sz="1400">
                        <a:effectLst/>
                      </a:endParaRP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ctr"/>
                      <a:endParaRPr lang="ja-JP" altLang="en-US" sz="1400">
                        <a:effectLst/>
                      </a:endParaRP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ctr"/>
                      <a:endParaRPr lang="ja-JP" altLang="en-US" sz="1400">
                        <a:effectLst/>
                      </a:endParaRP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42627215"/>
                  </a:ext>
                </a:extLst>
              </a:tr>
              <a:tr h="214946">
                <a:tc>
                  <a:txBody>
                    <a:bodyPr/>
                    <a:lstStyle/>
                    <a:p>
                      <a:pPr rtl="0" fontAlgn="b"/>
                      <a:endParaRPr lang="ja-JP" altLang="en-US" sz="1400">
                        <a:effectLst/>
                      </a:endParaRPr>
                    </a:p>
                  </a:txBody>
                  <a:tcPr marL="19660" marR="19660" marT="13106" marB="13106" anchor="b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en-US" sz="1400" dirty="0">
                          <a:effectLst/>
                        </a:rPr>
                        <a:t>Median</a:t>
                      </a:r>
                      <a:r>
                        <a:rPr lang="ja-JP" altLang="en-US" sz="1400" dirty="0">
                          <a:effectLst/>
                        </a:rPr>
                        <a:t> </a:t>
                      </a:r>
                      <a:r>
                        <a:rPr lang="en-US" sz="1400" dirty="0">
                          <a:effectLst/>
                        </a:rPr>
                        <a:t>(min – max)</a:t>
                      </a:r>
                    </a:p>
                  </a:txBody>
                  <a:tcPr marL="19660" marR="19660" marT="13106" marB="13106" anchor="b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>
                          <a:effectLst/>
                        </a:rPr>
                        <a:t>68(60.0-85.0)</a:t>
                      </a: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>
                          <a:effectLst/>
                        </a:rPr>
                        <a:t>67(60.0-85.0)</a:t>
                      </a: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>
                          <a:effectLst/>
                        </a:rPr>
                        <a:t>67(60.0-85.0)</a:t>
                      </a: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33708948"/>
                  </a:ext>
                </a:extLst>
              </a:tr>
              <a:tr h="214946">
                <a:tc gridSpan="2">
                  <a:txBody>
                    <a:bodyPr/>
                    <a:lstStyle/>
                    <a:p>
                      <a:pPr rtl="0" fontAlgn="b"/>
                      <a:r>
                        <a:rPr lang="en-US" sz="1400" b="1">
                          <a:effectLst/>
                        </a:rPr>
                        <a:t>Sex</a:t>
                      </a:r>
                    </a:p>
                  </a:txBody>
                  <a:tcPr marL="19660" marR="19660" marT="13106" marB="13106" anchor="b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0" fontAlgn="ctr"/>
                      <a:endParaRPr lang="ja-JP" altLang="en-US" sz="1400">
                        <a:effectLst/>
                      </a:endParaRP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ctr"/>
                      <a:endParaRPr lang="ja-JP" altLang="en-US" sz="1400">
                        <a:effectLst/>
                      </a:endParaRP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ctr"/>
                      <a:endParaRPr lang="ja-JP" altLang="en-US" sz="1400">
                        <a:effectLst/>
                      </a:endParaRP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48274297"/>
                  </a:ext>
                </a:extLst>
              </a:tr>
              <a:tr h="214946">
                <a:tc>
                  <a:txBody>
                    <a:bodyPr/>
                    <a:lstStyle/>
                    <a:p>
                      <a:pPr rtl="0" fontAlgn="b"/>
                      <a:endParaRPr lang="ja-JP" altLang="en-US" sz="1400">
                        <a:effectLst/>
                      </a:endParaRPr>
                    </a:p>
                  </a:txBody>
                  <a:tcPr marL="19660" marR="19660" marT="13106" marB="13106" anchor="b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en-US" sz="1400" dirty="0">
                          <a:effectLst/>
                        </a:rPr>
                        <a:t>Male</a:t>
                      </a:r>
                    </a:p>
                  </a:txBody>
                  <a:tcPr marL="19660" marR="19660" marT="13106" marB="13106" anchor="b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>
                          <a:effectLst/>
                        </a:rPr>
                        <a:t>36 (69.2%)</a:t>
                      </a: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>
                          <a:effectLst/>
                        </a:rPr>
                        <a:t>28 (52.8%)</a:t>
                      </a: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>
                          <a:effectLst/>
                        </a:rPr>
                        <a:t>64 (61.0%)</a:t>
                      </a: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61362202"/>
                  </a:ext>
                </a:extLst>
              </a:tr>
              <a:tr h="214946">
                <a:tc gridSpan="2">
                  <a:txBody>
                    <a:bodyPr/>
                    <a:lstStyle/>
                    <a:p>
                      <a:pPr rtl="0" fontAlgn="b"/>
                      <a:r>
                        <a:rPr lang="en-US" sz="1400" b="1" dirty="0">
                          <a:effectLst/>
                        </a:rPr>
                        <a:t>ECOG PS</a:t>
                      </a:r>
                    </a:p>
                  </a:txBody>
                  <a:tcPr marL="19660" marR="19660" marT="13106" marB="13106" anchor="b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0" fontAlgn="ctr"/>
                      <a:endParaRPr lang="ja-JP" altLang="en-US" sz="1400">
                        <a:effectLst/>
                      </a:endParaRP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ctr"/>
                      <a:endParaRPr lang="ja-JP" altLang="en-US" sz="1400">
                        <a:effectLst/>
                      </a:endParaRP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ctr"/>
                      <a:endParaRPr lang="ja-JP" altLang="en-US" sz="1400">
                        <a:effectLst/>
                      </a:endParaRP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12549861"/>
                  </a:ext>
                </a:extLst>
              </a:tr>
              <a:tr h="214946">
                <a:tc>
                  <a:txBody>
                    <a:bodyPr/>
                    <a:lstStyle/>
                    <a:p>
                      <a:pPr rtl="0" fontAlgn="b"/>
                      <a:endParaRPr lang="ja-JP" altLang="en-US" sz="1400">
                        <a:effectLst/>
                      </a:endParaRPr>
                    </a:p>
                  </a:txBody>
                  <a:tcPr marL="19660" marR="19660" marT="13106" marB="13106" anchor="b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en-US" altLang="ja-JP" sz="1400">
                          <a:effectLst/>
                        </a:rPr>
                        <a:t>0</a:t>
                      </a:r>
                    </a:p>
                  </a:txBody>
                  <a:tcPr marL="19660" marR="19660" marT="13106" marB="13106" anchor="b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>
                          <a:effectLst/>
                        </a:rPr>
                        <a:t>41 (78.8%)</a:t>
                      </a: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>
                          <a:effectLst/>
                        </a:rPr>
                        <a:t>38 (71.7%)</a:t>
                      </a: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>
                          <a:effectLst/>
                        </a:rPr>
                        <a:t>79 (75.2%)</a:t>
                      </a: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98486861"/>
                  </a:ext>
                </a:extLst>
              </a:tr>
              <a:tr h="214946">
                <a:tc>
                  <a:txBody>
                    <a:bodyPr/>
                    <a:lstStyle/>
                    <a:p>
                      <a:pPr rtl="0" fontAlgn="b"/>
                      <a:endParaRPr lang="ja-JP" altLang="en-US" sz="1400">
                        <a:effectLst/>
                      </a:endParaRPr>
                    </a:p>
                  </a:txBody>
                  <a:tcPr marL="19660" marR="19660" marT="13106" marB="13106" anchor="b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en-US" altLang="ja-JP" sz="1400">
                          <a:effectLst/>
                        </a:rPr>
                        <a:t>1</a:t>
                      </a:r>
                    </a:p>
                  </a:txBody>
                  <a:tcPr marL="19660" marR="19660" marT="13106" marB="13106" anchor="b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>
                          <a:effectLst/>
                        </a:rPr>
                        <a:t>7 (13.5%)</a:t>
                      </a: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>
                          <a:effectLst/>
                        </a:rPr>
                        <a:t>13 (24.5%)</a:t>
                      </a: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>
                          <a:effectLst/>
                        </a:rPr>
                        <a:t>20 (19.0%)</a:t>
                      </a: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69632155"/>
                  </a:ext>
                </a:extLst>
              </a:tr>
              <a:tr h="214946">
                <a:tc>
                  <a:txBody>
                    <a:bodyPr/>
                    <a:lstStyle/>
                    <a:p>
                      <a:pPr rtl="0" fontAlgn="b"/>
                      <a:endParaRPr lang="ja-JP" altLang="en-US" sz="1400">
                        <a:effectLst/>
                      </a:endParaRPr>
                    </a:p>
                  </a:txBody>
                  <a:tcPr marL="19660" marR="19660" marT="13106" marB="13106" anchor="b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en-US" altLang="ja-JP" sz="1400" dirty="0">
                          <a:effectLst/>
                        </a:rPr>
                        <a:t>2</a:t>
                      </a:r>
                    </a:p>
                  </a:txBody>
                  <a:tcPr marL="19660" marR="19660" marT="13106" marB="13106" anchor="b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>
                          <a:effectLst/>
                        </a:rPr>
                        <a:t>4 (7.7%)</a:t>
                      </a: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>
                          <a:effectLst/>
                        </a:rPr>
                        <a:t>2 (3.8%)</a:t>
                      </a: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>
                          <a:effectLst/>
                        </a:rPr>
                        <a:t>6 (5.7%)</a:t>
                      </a: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00643725"/>
                  </a:ext>
                </a:extLst>
              </a:tr>
              <a:tr h="256886">
                <a:tc gridSpan="2">
                  <a:txBody>
                    <a:bodyPr/>
                    <a:lstStyle/>
                    <a:p>
                      <a:pPr rtl="0" fontAlgn="b"/>
                      <a:r>
                        <a:rPr lang="en-US" sz="1400" b="1" dirty="0">
                          <a:solidFill>
                            <a:schemeClr val="tx1"/>
                          </a:solidFill>
                          <a:effectLst/>
                        </a:rPr>
                        <a:t>WHO2017  Major subtypes / Minor subtypes</a:t>
                      </a:r>
                    </a:p>
                  </a:txBody>
                  <a:tcPr marL="19660" marR="19660" marT="13106" marB="13106" anchor="b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rtl="0" fontAlgn="ctr"/>
                      <a:endParaRPr lang="ja-JP" altLang="en-US" sz="1400">
                        <a:effectLst/>
                      </a:endParaRP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ctr"/>
                      <a:endParaRPr lang="ja-JP" altLang="en-US" sz="1400">
                        <a:effectLst/>
                      </a:endParaRP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rtl="0" fontAlgn="ctr"/>
                      <a:endParaRPr lang="ja-JP" altLang="en-US" sz="1400">
                        <a:effectLst/>
                      </a:endParaRP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14918862"/>
                  </a:ext>
                </a:extLst>
              </a:tr>
              <a:tr h="256886">
                <a:tc>
                  <a:txBody>
                    <a:bodyPr/>
                    <a:lstStyle/>
                    <a:p>
                      <a:pPr rtl="0" fontAlgn="b"/>
                      <a:endParaRPr lang="ja-JP" altLang="en-US" sz="1400">
                        <a:effectLst/>
                      </a:endParaRPr>
                    </a:p>
                  </a:txBody>
                  <a:tcPr marL="19660" marR="19660" marT="13106" marB="13106" anchor="b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en-US" sz="1400">
                          <a:effectLst/>
                        </a:rPr>
                        <a:t>AML with recurrent genetic abnormalities / inv(16)(p13.1q22) or t(16;16)(p13.1;q22);CBFB-MYH11</a:t>
                      </a:r>
                    </a:p>
                  </a:txBody>
                  <a:tcPr marL="19660" marR="19660" marT="13106" marB="13106" anchor="b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>
                          <a:effectLst/>
                        </a:rPr>
                        <a:t>2 (3.8%)</a:t>
                      </a: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>
                          <a:effectLst/>
                        </a:rPr>
                        <a:t>4 (7.5%)</a:t>
                      </a: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>
                          <a:effectLst/>
                        </a:rPr>
                        <a:t>6 (5.7%)</a:t>
                      </a: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97902011"/>
                  </a:ext>
                </a:extLst>
              </a:tr>
              <a:tr h="256886">
                <a:tc>
                  <a:txBody>
                    <a:bodyPr/>
                    <a:lstStyle/>
                    <a:p>
                      <a:pPr rtl="0" fontAlgn="b"/>
                      <a:endParaRPr lang="ja-JP" altLang="en-US" sz="1400">
                        <a:effectLst/>
                      </a:endParaRPr>
                    </a:p>
                  </a:txBody>
                  <a:tcPr marL="19660" marR="19660" marT="13106" marB="13106" anchor="b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en-US" sz="1400">
                          <a:effectLst/>
                        </a:rPr>
                        <a:t>AML with recurrent genetic abnormalities / t(8;21)(q22;q22); RUNX1-RUNX1T1</a:t>
                      </a:r>
                    </a:p>
                  </a:txBody>
                  <a:tcPr marL="19660" marR="19660" marT="13106" marB="13106" anchor="b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>
                          <a:effectLst/>
                        </a:rPr>
                        <a:t>2 (3.8%)</a:t>
                      </a: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>
                          <a:effectLst/>
                        </a:rPr>
                        <a:t>4 (7.5%)</a:t>
                      </a: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>
                          <a:effectLst/>
                        </a:rPr>
                        <a:t>6 (5.7%)</a:t>
                      </a: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49281486"/>
                  </a:ext>
                </a:extLst>
              </a:tr>
              <a:tr h="214946">
                <a:tc>
                  <a:txBody>
                    <a:bodyPr/>
                    <a:lstStyle/>
                    <a:p>
                      <a:pPr rtl="0" fontAlgn="b"/>
                      <a:endParaRPr lang="ja-JP" altLang="en-US" sz="1400">
                        <a:effectLst/>
                      </a:endParaRPr>
                    </a:p>
                  </a:txBody>
                  <a:tcPr marL="19660" marR="19660" marT="13106" marB="13106" anchor="b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en-US" sz="1400">
                          <a:effectLst/>
                        </a:rPr>
                        <a:t>AML with recurrent genetic abnormalities / Mutated NPM1</a:t>
                      </a:r>
                    </a:p>
                  </a:txBody>
                  <a:tcPr marL="19660" marR="19660" marT="13106" marB="13106" anchor="b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>
                          <a:effectLst/>
                        </a:rPr>
                        <a:t>0 (0.0%)</a:t>
                      </a: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>
                          <a:effectLst/>
                        </a:rPr>
                        <a:t>2 (3.8%)</a:t>
                      </a: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>
                          <a:effectLst/>
                        </a:rPr>
                        <a:t>2 (1.9%)</a:t>
                      </a: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40561328"/>
                  </a:ext>
                </a:extLst>
              </a:tr>
              <a:tr h="214946">
                <a:tc>
                  <a:txBody>
                    <a:bodyPr/>
                    <a:lstStyle/>
                    <a:p>
                      <a:pPr rtl="0" fontAlgn="b"/>
                      <a:endParaRPr lang="ja-JP" altLang="en-US" sz="1400">
                        <a:effectLst/>
                      </a:endParaRPr>
                    </a:p>
                  </a:txBody>
                  <a:tcPr marL="19660" marR="19660" marT="13106" marB="13106" anchor="b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en-US" sz="1400">
                          <a:effectLst/>
                        </a:rPr>
                        <a:t>AML, NOS / AML with minimal differentiation</a:t>
                      </a:r>
                    </a:p>
                  </a:txBody>
                  <a:tcPr marL="19660" marR="19660" marT="13106" marB="13106" anchor="b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>
                          <a:effectLst/>
                        </a:rPr>
                        <a:t>2 (3.8%)</a:t>
                      </a: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>
                          <a:effectLst/>
                        </a:rPr>
                        <a:t>5 (9.4%)</a:t>
                      </a: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>
                          <a:effectLst/>
                        </a:rPr>
                        <a:t>7 (6.7%)</a:t>
                      </a: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04805168"/>
                  </a:ext>
                </a:extLst>
              </a:tr>
              <a:tr h="214946">
                <a:tc>
                  <a:txBody>
                    <a:bodyPr/>
                    <a:lstStyle/>
                    <a:p>
                      <a:pPr rtl="0" fontAlgn="b"/>
                      <a:endParaRPr lang="ja-JP" altLang="en-US" sz="1400">
                        <a:effectLst/>
                      </a:endParaRPr>
                    </a:p>
                  </a:txBody>
                  <a:tcPr marL="19660" marR="19660" marT="13106" marB="13106" anchor="b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en-US" sz="1400">
                          <a:effectLst/>
                        </a:rPr>
                        <a:t>AML, NOS / AML with maturation</a:t>
                      </a:r>
                    </a:p>
                  </a:txBody>
                  <a:tcPr marL="19660" marR="19660" marT="13106" marB="13106" anchor="b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>
                          <a:effectLst/>
                        </a:rPr>
                        <a:t>18 (34.6%)</a:t>
                      </a: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>
                          <a:effectLst/>
                        </a:rPr>
                        <a:t>18 (34.0%)</a:t>
                      </a: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>
                          <a:effectLst/>
                        </a:rPr>
                        <a:t>36 (34.3%)</a:t>
                      </a: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65696836"/>
                  </a:ext>
                </a:extLst>
              </a:tr>
              <a:tr h="214946">
                <a:tc>
                  <a:txBody>
                    <a:bodyPr/>
                    <a:lstStyle/>
                    <a:p>
                      <a:pPr rtl="0" fontAlgn="b"/>
                      <a:endParaRPr lang="ja-JP" altLang="en-US" sz="1400">
                        <a:effectLst/>
                      </a:endParaRPr>
                    </a:p>
                  </a:txBody>
                  <a:tcPr marL="19660" marR="19660" marT="13106" marB="13106" anchor="b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en-US" sz="1400">
                          <a:effectLst/>
                        </a:rPr>
                        <a:t>AML, NOS / AML without maturation</a:t>
                      </a:r>
                    </a:p>
                  </a:txBody>
                  <a:tcPr marL="19660" marR="19660" marT="13106" marB="13106" anchor="b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>
                          <a:effectLst/>
                        </a:rPr>
                        <a:t>14 (26.9%)</a:t>
                      </a: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>
                          <a:effectLst/>
                        </a:rPr>
                        <a:t>5 (9.4%)</a:t>
                      </a: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>
                          <a:effectLst/>
                        </a:rPr>
                        <a:t>19 (18.1%)</a:t>
                      </a: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71986518"/>
                  </a:ext>
                </a:extLst>
              </a:tr>
              <a:tr h="214946">
                <a:tc>
                  <a:txBody>
                    <a:bodyPr/>
                    <a:lstStyle/>
                    <a:p>
                      <a:pPr rtl="0" fontAlgn="b"/>
                      <a:endParaRPr lang="ja-JP" altLang="en-US" sz="1400">
                        <a:effectLst/>
                      </a:endParaRPr>
                    </a:p>
                  </a:txBody>
                  <a:tcPr marL="19660" marR="19660" marT="13106" marB="13106" anchor="b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en-US" sz="1400">
                          <a:effectLst/>
                        </a:rPr>
                        <a:t>AML, NOS / Acute Myelomonocytic Leukemia</a:t>
                      </a:r>
                    </a:p>
                  </a:txBody>
                  <a:tcPr marL="19660" marR="19660" marT="13106" marB="13106" anchor="b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>
                          <a:effectLst/>
                        </a:rPr>
                        <a:t>7 (13.5%)</a:t>
                      </a: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>
                          <a:effectLst/>
                        </a:rPr>
                        <a:t>8 (15.1%)</a:t>
                      </a: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>
                          <a:effectLst/>
                        </a:rPr>
                        <a:t>15 (14.3%)</a:t>
                      </a: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43618336"/>
                  </a:ext>
                </a:extLst>
              </a:tr>
              <a:tr h="214946">
                <a:tc>
                  <a:txBody>
                    <a:bodyPr/>
                    <a:lstStyle/>
                    <a:p>
                      <a:pPr rtl="0" fontAlgn="b"/>
                      <a:endParaRPr lang="ja-JP" altLang="en-US" sz="1400">
                        <a:effectLst/>
                      </a:endParaRPr>
                    </a:p>
                  </a:txBody>
                  <a:tcPr marL="19660" marR="19660" marT="13106" marB="13106" anchor="b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fr-FR" sz="1400">
                          <a:effectLst/>
                        </a:rPr>
                        <a:t>AML, NOS / Pure erythroid leukemia</a:t>
                      </a:r>
                    </a:p>
                  </a:txBody>
                  <a:tcPr marL="19660" marR="19660" marT="13106" marB="13106" anchor="b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>
                          <a:effectLst/>
                        </a:rPr>
                        <a:t>0 (0.0%)</a:t>
                      </a: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>
                          <a:effectLst/>
                        </a:rPr>
                        <a:t>1 (1.9%)</a:t>
                      </a: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>
                          <a:effectLst/>
                        </a:rPr>
                        <a:t>1 (1.0%)</a:t>
                      </a: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14537122"/>
                  </a:ext>
                </a:extLst>
              </a:tr>
              <a:tr h="214946">
                <a:tc>
                  <a:txBody>
                    <a:bodyPr/>
                    <a:lstStyle/>
                    <a:p>
                      <a:pPr rtl="0" fontAlgn="b"/>
                      <a:endParaRPr lang="ja-JP" altLang="en-US" sz="1400">
                        <a:effectLst/>
                      </a:endParaRPr>
                    </a:p>
                  </a:txBody>
                  <a:tcPr marL="19660" marR="19660" marT="13106" marB="13106" anchor="b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 fontAlgn="b"/>
                      <a:r>
                        <a:rPr lang="en-US" sz="1400">
                          <a:effectLst/>
                        </a:rPr>
                        <a:t>AML with myelodysplasia-related changes </a:t>
                      </a:r>
                    </a:p>
                  </a:txBody>
                  <a:tcPr marL="19660" marR="19660" marT="13106" marB="13106" anchor="b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>
                          <a:effectLst/>
                        </a:rPr>
                        <a:t>7 (13.5%)</a:t>
                      </a: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>
                          <a:effectLst/>
                        </a:rPr>
                        <a:t>6 (11.3%)</a:t>
                      </a: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US" altLang="ja-JP" sz="1400" dirty="0">
                          <a:effectLst/>
                        </a:rPr>
                        <a:t>13 (12.4%)</a:t>
                      </a:r>
                    </a:p>
                  </a:txBody>
                  <a:tcPr marL="19660" marR="19660" marT="13106" marB="13106" anchor="ctr">
                    <a:lnL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9525" cap="flat" cmpd="sng" algn="ctr">
                      <a:solidFill>
                        <a:srgbClr val="CCCCCC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9525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7214617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7567894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図 9">
            <a:extLst>
              <a:ext uri="{FF2B5EF4-FFF2-40B4-BE49-F238E27FC236}">
                <a16:creationId xmlns:a16="http://schemas.microsoft.com/office/drawing/2014/main" id="{86039DE8-6C32-B4CD-BF95-92FCCFDC83A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9785"/>
          <a:stretch/>
        </p:blipFill>
        <p:spPr>
          <a:xfrm rot="5400000">
            <a:off x="3982530" y="-291559"/>
            <a:ext cx="4226940" cy="7915576"/>
          </a:xfrm>
          <a:prstGeom prst="rect">
            <a:avLst/>
          </a:prstGeom>
        </p:spPr>
      </p:pic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183FD14F-3A39-F14F-9C31-22A8086FD417}"/>
              </a:ext>
            </a:extLst>
          </p:cNvPr>
          <p:cNvSpPr txBox="1"/>
          <p:nvPr/>
        </p:nvSpPr>
        <p:spPr>
          <a:xfrm>
            <a:off x="798285" y="374134"/>
            <a:ext cx="10638971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kumimoji="1" lang="en-US" altLang="ja-JP" sz="2000" dirty="0"/>
              <a:t>[Suppl. Figure 1]  Peripheral </a:t>
            </a:r>
            <a:r>
              <a:rPr kumimoji="1" lang="en-US" altLang="ja-JP" sz="2000" i="1" dirty="0"/>
              <a:t>WT1</a:t>
            </a:r>
            <a:r>
              <a:rPr kumimoji="1" lang="en-US" altLang="ja-JP" sz="2000" dirty="0"/>
              <a:t> mRNA in the OCV-501 and placebo groups (Ref. 11)</a:t>
            </a:r>
            <a:endParaRPr lang="ja-JP" altLang="en-US" sz="2000"/>
          </a:p>
        </p:txBody>
      </p:sp>
    </p:spTree>
    <p:extLst>
      <p:ext uri="{BB962C8B-B14F-4D97-AF65-F5344CB8AC3E}">
        <p14:creationId xmlns:p14="http://schemas.microsoft.com/office/powerpoint/2010/main" val="40104271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41CEFBF-4F9B-D96E-570A-2C267FCC70F6}"/>
              </a:ext>
            </a:extLst>
          </p:cNvPr>
          <p:cNvSpPr txBox="1">
            <a:spLocks/>
          </p:cNvSpPr>
          <p:nvPr/>
        </p:nvSpPr>
        <p:spPr>
          <a:xfrm>
            <a:off x="469629" y="395605"/>
            <a:ext cx="11236415" cy="1325563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400" dirty="0"/>
              <a:t>[Suppl. Figure 2]</a:t>
            </a:r>
            <a:r>
              <a:rPr lang="ja-JP" altLang="en-US" sz="2400" dirty="0"/>
              <a:t>　</a:t>
            </a:r>
            <a:r>
              <a:rPr lang="en-US" altLang="ja-JP" sz="2400" dirty="0"/>
              <a:t>Significant WT1-specific IgG response was observed in the OCV-501 group by the 25</a:t>
            </a:r>
            <a:r>
              <a:rPr lang="en-US" altLang="ja-JP" sz="2400" baseline="30000" dirty="0"/>
              <a:t>th</a:t>
            </a:r>
            <a:r>
              <a:rPr lang="en-US" altLang="ja-JP" sz="2400" dirty="0"/>
              <a:t> week (Ref. 11) </a:t>
            </a:r>
            <a:endParaRPr lang="ja-JP" altLang="en-US" sz="2400" dirty="0"/>
          </a:p>
        </p:txBody>
      </p:sp>
      <p:grpSp>
        <p:nvGrpSpPr>
          <p:cNvPr id="7" name="グループ化 6">
            <a:extLst>
              <a:ext uri="{FF2B5EF4-FFF2-40B4-BE49-F238E27FC236}">
                <a16:creationId xmlns:a16="http://schemas.microsoft.com/office/drawing/2014/main" id="{1CE8505D-2C3B-D6D5-500D-FFDE41E04B88}"/>
              </a:ext>
            </a:extLst>
          </p:cNvPr>
          <p:cNvGrpSpPr/>
          <p:nvPr/>
        </p:nvGrpSpPr>
        <p:grpSpPr>
          <a:xfrm>
            <a:off x="1364343" y="1721169"/>
            <a:ext cx="8766543" cy="4695368"/>
            <a:chOff x="1364343" y="1721169"/>
            <a:chExt cx="8766543" cy="4695368"/>
          </a:xfrm>
        </p:grpSpPr>
        <p:pic>
          <p:nvPicPr>
            <p:cNvPr id="3" name="図 2">
              <a:extLst>
                <a:ext uri="{FF2B5EF4-FFF2-40B4-BE49-F238E27FC236}">
                  <a16:creationId xmlns:a16="http://schemas.microsoft.com/office/drawing/2014/main" id="{4B375A48-A71F-F135-2B5D-30A5DDCA628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/>
            <a:srcRect l="9010" b="3344"/>
            <a:stretch/>
          </p:blipFill>
          <p:spPr>
            <a:xfrm rot="5400000">
              <a:off x="3399931" y="-314419"/>
              <a:ext cx="4695368" cy="8766543"/>
            </a:xfrm>
            <a:prstGeom prst="rect">
              <a:avLst/>
            </a:prstGeom>
          </p:spPr>
        </p:pic>
        <p:cxnSp>
          <p:nvCxnSpPr>
            <p:cNvPr id="5" name="直線コネクタ 4">
              <a:extLst>
                <a:ext uri="{FF2B5EF4-FFF2-40B4-BE49-F238E27FC236}">
                  <a16:creationId xmlns:a16="http://schemas.microsoft.com/office/drawing/2014/main" id="{F72D897A-7BFB-0CC1-2772-8DEEAFD28681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135086" y="2046514"/>
              <a:ext cx="0" cy="3962400"/>
            </a:xfrm>
            <a:prstGeom prst="line">
              <a:avLst/>
            </a:prstGeom>
            <a:ln w="38100">
              <a:prstDash val="dash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43403555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7455AB2E-29CA-60E6-F1DD-55F8B31C08AC}"/>
              </a:ext>
            </a:extLst>
          </p:cNvPr>
          <p:cNvSpPr txBox="1"/>
          <p:nvPr/>
        </p:nvSpPr>
        <p:spPr>
          <a:xfrm>
            <a:off x="537030" y="384249"/>
            <a:ext cx="8952654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800" dirty="0"/>
              <a:t>[Suppl. Fig.3] OCV-501-specific </a:t>
            </a:r>
            <a:r>
              <a:rPr kumimoji="1" lang="en-US" altLang="ja-JP" sz="2800" dirty="0" err="1"/>
              <a:t>IFN</a:t>
            </a:r>
            <a:r>
              <a:rPr kumimoji="1" lang="en-US" altLang="ja-JP" sz="2800" dirty="0" err="1">
                <a:latin typeface="Symbol" pitchFamily="2" charset="2"/>
              </a:rPr>
              <a:t>g</a:t>
            </a:r>
            <a:r>
              <a:rPr kumimoji="1" lang="en-US" altLang="ja-JP" sz="2800" dirty="0">
                <a:latin typeface="Symbol" pitchFamily="2" charset="2"/>
              </a:rPr>
              <a:t> </a:t>
            </a:r>
            <a:r>
              <a:rPr kumimoji="1" lang="en-US" altLang="ja-JP" sz="2800" dirty="0"/>
              <a:t>response in the OCV-501 and placebo groups (Ref. 11)</a:t>
            </a:r>
            <a:endParaRPr kumimoji="1" lang="ja-JP" altLang="en-US" sz="2800" dirty="0">
              <a:latin typeface="Symbol" pitchFamily="2" charset="2"/>
            </a:endParaRPr>
          </a:p>
        </p:txBody>
      </p: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F5B1E317-AA10-E21D-1824-51E1C1DF7E57}"/>
              </a:ext>
            </a:extLst>
          </p:cNvPr>
          <p:cNvGrpSpPr/>
          <p:nvPr/>
        </p:nvGrpSpPr>
        <p:grpSpPr>
          <a:xfrm>
            <a:off x="1553029" y="1984075"/>
            <a:ext cx="8223593" cy="4308521"/>
            <a:chOff x="1553029" y="1984075"/>
            <a:chExt cx="8223593" cy="4308521"/>
          </a:xfrm>
        </p:grpSpPr>
        <p:pic>
          <p:nvPicPr>
            <p:cNvPr id="3" name="図 2">
              <a:extLst>
                <a:ext uri="{FF2B5EF4-FFF2-40B4-BE49-F238E27FC236}">
                  <a16:creationId xmlns:a16="http://schemas.microsoft.com/office/drawing/2014/main" id="{ADA4CFD0-948A-C35D-D7BA-7A2C22BE644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10409"/>
            <a:stretch/>
          </p:blipFill>
          <p:spPr>
            <a:xfrm rot="5400000">
              <a:off x="3510565" y="26539"/>
              <a:ext cx="4308521" cy="8223593"/>
            </a:xfrm>
            <a:prstGeom prst="rect">
              <a:avLst/>
            </a:prstGeom>
          </p:spPr>
        </p:pic>
        <p:cxnSp>
          <p:nvCxnSpPr>
            <p:cNvPr id="10" name="直線コネクタ 9">
              <a:extLst>
                <a:ext uri="{FF2B5EF4-FFF2-40B4-BE49-F238E27FC236}">
                  <a16:creationId xmlns:a16="http://schemas.microsoft.com/office/drawing/2014/main" id="{E68E1863-B74C-9C4B-8C84-F7EB5CF5E884}"/>
                </a:ext>
              </a:extLst>
            </p:cNvPr>
            <p:cNvCxnSpPr>
              <a:cxnSpLocks/>
            </p:cNvCxnSpPr>
            <p:nvPr/>
          </p:nvCxnSpPr>
          <p:spPr>
            <a:xfrm>
              <a:off x="2362541" y="3600775"/>
              <a:ext cx="7221406" cy="0"/>
            </a:xfrm>
            <a:prstGeom prst="line">
              <a:avLst/>
            </a:prstGeom>
            <a:ln w="28575">
              <a:prstDash val="dash"/>
            </a:ln>
          </p:spPr>
          <p:style>
            <a:lnRef idx="1">
              <a:schemeClr val="accent2"/>
            </a:lnRef>
            <a:fillRef idx="0">
              <a:schemeClr val="accent2"/>
            </a:fillRef>
            <a:effectRef idx="0">
              <a:schemeClr val="accent2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8085623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9</TotalTime>
  <Words>394</Words>
  <Application>Microsoft Office PowerPoint</Application>
  <PresentationFormat>ワイド画面</PresentationFormat>
  <Paragraphs>75</Paragraphs>
  <Slides>4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9" baseType="lpstr">
      <vt:lpstr>游ゴシック</vt:lpstr>
      <vt:lpstr>游ゴシック Light</vt:lpstr>
      <vt:lpstr>Arial</vt:lpstr>
      <vt:lpstr>Symbol</vt:lpstr>
      <vt:lpstr>Office テーマ</vt:lpstr>
      <vt:lpstr>[Suppl. Table 1] Patients' characteristics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[Suppl. Table 1] Patients' characteristics</dc:title>
  <dc:creator>NAOE TOMOKI</dc:creator>
  <cp:lastModifiedBy>直江　知樹／Naoe,Tomoki</cp:lastModifiedBy>
  <cp:revision>3</cp:revision>
  <cp:lastPrinted>2023-02-07T02:43:23Z</cp:lastPrinted>
  <dcterms:created xsi:type="dcterms:W3CDTF">2023-02-04T02:20:32Z</dcterms:created>
  <dcterms:modified xsi:type="dcterms:W3CDTF">2023-02-07T05:50:16Z</dcterms:modified>
</cp:coreProperties>
</file>